
<file path=[Content_Types].xml><?xml version="1.0" encoding="utf-8"?>
<Types xmlns="http://schemas.openxmlformats.org/package/2006/content-types">
  <Default Extension="jpeg" ContentType="image/jpeg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4"/>
  </p:notesMasterIdLst>
  <p:sldIdLst>
    <p:sldId id="49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DBAF1B-8278-4964-8818-C3796EA16070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DF3BBB-7FD9-4036-AE15-C233E8AF1C6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2707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7298DA-4F9D-FAB2-55BD-C269AC2448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65E7CA-9FFA-51F4-B1C5-7214D878AB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F958F-B6D1-9A72-E9BA-9E9B5B993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C9A2D0-29B0-5F3A-486A-02CCCD1492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23E381-EB1E-8E1F-FAB5-3ECC6A8EB1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65312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B808E3-A445-6A11-4982-806D4762CB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6A17FA-3F31-FEF1-E659-2FC177F38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05B808-7EE6-79D1-4EC6-48CB7E36C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BFB91E-9783-71B5-5334-D92E19A06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14E817-30B4-520C-1690-086E8F360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10897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A0F1D4-5775-1B04-CFFC-C7F2950BA2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6BDC13-DC96-76A1-BA85-92774A4492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8E3F4A-5D4A-82F6-B088-76774B126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982726-B54D-C789-9EB6-315260C153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61A568-59BC-DE07-B3CA-DF0329F21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0341645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7700CA-9D9D-D055-60B3-A22ED4D20D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784BDE2-3086-AB6A-9408-880C25FAA8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B70C87-08D0-58A1-0424-4B433948FD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7E87E8-FB71-B969-2273-90F6E9A93E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62FBBF-3FC1-E20D-99B2-83EB1E9BE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0920818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9EB206-2AEC-B948-2146-383DC007CD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2F63C6-5895-7307-3180-FD1C07B5F2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EC45C2-C6C7-EF8E-A2CD-84B242D348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FBACF1-0745-4356-F4FA-7AD9E0207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CC50FC-AFDE-2213-19CE-91BBEBEDB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752506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070C97-1C76-A977-3822-B326E8B66E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B6A869-B5D2-6427-BB60-25222A1A80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18C2CE-9537-1AC2-CB38-FD1C777477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77161F-B52D-D36B-35AA-ACA319BF24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492CB6-C9CD-A851-4DC1-CE9EFADDAB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7821721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DE83F5-03BE-679B-AD8C-BD7C779C6D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0FC1EE-1D7A-0965-3DC6-8C1452ACDE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BC85599-D62F-07EB-D396-1A980E898A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E821E6-50A9-4E17-1153-259946383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49E6B7-094B-37FA-5863-54FEBBA79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128417-BD7F-2456-CBBC-74B8F21564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2359647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CA3AC-0B7A-B1C4-8D1D-2A47576109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DBA412-11E6-AEBB-D438-83C1556F01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B1C1A3-15D5-D785-F2C8-0A62CB879F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D45A60D-C8C2-C3BC-0D01-AEECFF32F4E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A8EDBB7-6AAC-2B36-EC95-C601675996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8C793B-1D9B-E141-AF81-3A47985C8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3F1DF57-53D1-CE63-817D-73779343F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A58D02C-98BF-2CF7-67CF-12163C65A0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7133617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D8D2D1-11D5-0394-3CAC-33106C0119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9E6445A-C590-2009-7525-D729C04AC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4ED1844-021D-61D6-F284-D894DEA083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71B1474-546A-7D96-3FA8-D4D4FC6FED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1498967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89A1390-81E0-2504-0893-E147919CC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4AE209D-CD0C-707C-76A8-A63D7158E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04F703-222F-37D5-30CD-D613510EF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5489964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606B24-E865-F183-83CB-DDE013D3B6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167C77-7233-F214-7440-C794B0FE2E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D4BE6F-3CA2-E4A5-6641-13B5E62B71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277DC3-11CC-9DE7-E35B-A9C410B46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8B3FB8-4C8B-1F7A-6B3A-9B9F404080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2B823F-DF56-38DE-D52D-3DC433F30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233013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A930CB-4AE0-032A-5692-D81CA12F27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A7FABA-8B01-B134-9CF9-4E26B88286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3D0B9D-3798-7D50-9702-AAEA4AC75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55ADFA-856E-E343-89AC-7D88E015E3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23788B-D56B-0304-8079-8D1AB6C5E6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010772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791163-909A-6A22-6AE1-282ACAC67A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F23FE12-701F-6B1A-6297-3A481DEC89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19E3B3-0883-EB71-A8D2-E1271A2FE4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8A2C61-8802-EE23-A9C0-2F43B7734C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0730DA-3B75-FFCF-20E6-28698194A6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51B565-9A02-652E-900B-5DA5CA0471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507286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38725D-7E42-E7BA-6D3C-CCBE7FE65D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4A5F4C-6886-F096-AB27-2E8B63F448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A9F8EF-7FD9-F347-FD67-1964E399C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056B90-78C1-BFC3-3FCB-839B4FDD9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6521D2-409B-419D-AAB1-4812148BD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34402891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448FC25-0699-18BD-1E05-462A8BB3B5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A2BAE6-ACE8-A171-77BD-A7C6323CAF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EF4C47-3E0F-49FA-53BF-FB951A2E4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E189CA-9C2C-C60A-DF0A-BA1230A19F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E3B2EE-BA4F-84BE-C5BD-5E952B8E11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55366844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idx="21"/>
          </p:nvPr>
        </p:nvSpPr>
        <p:spPr>
          <a:xfrm>
            <a:off x="6248408" y="-742950"/>
            <a:ext cx="5096935" cy="76454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895359" y="1822451"/>
            <a:ext cx="5003801" cy="4419600"/>
          </a:xfrm>
          <a:prstGeom prst="rect">
            <a:avLst/>
          </a:prstGeom>
        </p:spPr>
        <p:txBody>
          <a:bodyPr/>
          <a:lstStyle>
            <a:lvl1pPr marL="215887" indent="-215887">
              <a:spcBef>
                <a:spcPts val="2651"/>
              </a:spcBef>
              <a:defRPr sz="1900"/>
            </a:lvl1pPr>
            <a:lvl2pPr marL="431774" indent="-215887">
              <a:spcBef>
                <a:spcPts val="2651"/>
              </a:spcBef>
              <a:defRPr sz="1900"/>
            </a:lvl2pPr>
            <a:lvl3pPr marL="647662" indent="-215887">
              <a:spcBef>
                <a:spcPts val="2651"/>
              </a:spcBef>
              <a:defRPr sz="1900"/>
            </a:lvl3pPr>
            <a:lvl4pPr marL="863547" indent="-215887">
              <a:spcBef>
                <a:spcPts val="2651"/>
              </a:spcBef>
              <a:defRPr sz="1900"/>
            </a:lvl4pPr>
            <a:lvl5pPr marL="1079432" indent="-215887">
              <a:spcBef>
                <a:spcPts val="2651"/>
              </a:spcBef>
              <a:defRPr sz="19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 anchor="t"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367217353"/>
      </p:ext>
    </p:extLst>
  </p:cSld>
  <p:clrMapOvr>
    <a:masterClrMapping/>
  </p:clrMapOvr>
  <p:transition spd="med"/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295552261"/>
      </p:ext>
    </p:extLst>
  </p:cSld>
  <p:clrMapOvr>
    <a:masterClrMapping/>
  </p:clrMapOvr>
  <p:transition spd="med"/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 anchor="t"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161122252"/>
      </p:ext>
    </p:extLst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39C7D-F2D6-A4E0-A0D8-5830611112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BB438E-7CEF-E9C3-60D9-B9D0999CD4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AF4D46-8B70-35E8-07AB-DC394C35A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7C3931-F308-55A0-1B60-0AD15111D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45DCF-EFA4-37E3-991F-0159E67C7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34736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741EBB-D829-0E9D-8A37-888BBB2007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CC76F3-0F10-5DFA-B62C-939F1BD20B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333A63-9B12-2DEB-2CE1-1AE3547EAD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9F5DEF-57A7-FA35-0DE6-487FB35141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A21536-D74D-842D-621A-5DD1AF3FB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E2F49F-45E9-DA7D-E967-A5E00E62E9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725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3EFBBF-F17F-12F4-E4C1-088DE060A2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C752EF-2A68-01E3-61A8-94BA0FEBD9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877A6D-E365-ADAC-1A07-B82768F68D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3654B6-6CFE-61B2-3A16-AD648BBBC5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15FC14-2C18-1DD9-9060-5FB267AF9F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F1FB786-0028-A983-B6CE-5EE067E5D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0582CD-B2E0-CBFC-BBE2-19EA86655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5B00D54-0235-9CF2-1A29-9FD01E7F0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841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6369CD-4D23-8BFC-A542-2B92D890B2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D21CBA-51F0-88AD-F604-832CE87D0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CD55CA-98E7-46CF-7AB4-AFABA0973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22784CE-83CC-2EAC-9FEB-ACC3B17B7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0137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4040D52-7C1E-AB1D-798F-8BAE652C9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FFA8C7-33F2-02E5-7D2A-C0D1D7722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E02132B-E01A-6E46-F0F2-9273B9525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9271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1D4B46-A811-C07C-A508-0DF86A2E81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4E3D39-C1C6-B4B2-94B5-E3AD251DAB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5304D2-5DEA-1878-EA86-1275E25F19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E57E76-31E0-7F8D-E1F8-C0DAF968E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D6A111-82FD-9CDC-74BA-FBE7EE29F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1F2276-3ABC-51F8-BAED-E0F6F46D1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23459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B8B00F-6894-5048-42F0-6537E501A7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E7382-68F0-8ADD-E54A-F075972BDA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7FB87C-D120-E599-35B8-DC76CD2395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E7358D-B640-B4AE-D58C-6E698B070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29F8AA-1B45-7650-EE90-858F206DB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B9F684-B59A-4A16-4297-6850B3B0A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24482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slideLayout" Target="../slideLayouts/slideLayout24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5" Type="http://schemas.openxmlformats.org/officeDocument/2006/relationships/theme" Target="../theme/theme2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Relationship Id="rId14" Type="http://schemas.openxmlformats.org/officeDocument/2006/relationships/slideLayout" Target="../slideLayouts/slideLayout2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0F27173-DD36-2C49-9885-E5F44228A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3987A0-A5C9-B390-BE4B-D4F17764E4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9FF9C0-7219-1D1E-A1D4-A43C84BD67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DE0F85-0C1B-BA21-BF4A-39B26F1240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91B6E6-E829-B6B3-FBEE-083D5C9CC2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9029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5BF267-AB9B-C47C-04ED-DA6591DFB5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A77420-6536-ECAD-6F23-CACB0A52CB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2D4BD0-199B-0611-8714-B711A89260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2C9878-5344-42AB-B4AA-A99FC560360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03198A-F56D-A46F-A520-A1BBDEB98E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F18B4F-5177-34A5-8974-C74C0B8A45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080139-30B7-4678-B4A0-0C9417EF411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00117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5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2.jp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EAC401-24C6-45C3-96D9-773D637BE5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8813" y="1191881"/>
            <a:ext cx="11594373" cy="706216"/>
          </a:xfrm>
        </p:spPr>
        <p:txBody>
          <a:bodyPr>
            <a:normAutofit/>
          </a:bodyPr>
          <a:lstStyle/>
          <a:p>
            <a:r>
              <a:rPr lang="en-AU" sz="2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fects of GW on Chemical and Biological Balloon Surface Photo-MCT-3 Activation</a:t>
            </a:r>
          </a:p>
        </p:txBody>
      </p:sp>
      <p:pic>
        <p:nvPicPr>
          <p:cNvPr id="4" name="guidewire">
            <a:hlinkClick r:id="" action="ppaction://media"/>
            <a:extLst>
              <a:ext uri="{FF2B5EF4-FFF2-40B4-BE49-F238E27FC236}">
                <a16:creationId xmlns:a16="http://schemas.microsoft.com/office/drawing/2014/main" id="{0070C814-0284-49AE-BDF6-02E60327659E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24841" y="1434202"/>
            <a:ext cx="6818966" cy="383566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DF28023-1F10-4050-D727-55047D3EA57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45564" y="1434202"/>
            <a:ext cx="3667074" cy="515592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D42604A-79F4-CC89-A925-F259850A3404}"/>
              </a:ext>
            </a:extLst>
          </p:cNvPr>
          <p:cNvSpPr txBox="1"/>
          <p:nvPr/>
        </p:nvSpPr>
        <p:spPr>
          <a:xfrm>
            <a:off x="4038459" y="326207"/>
            <a:ext cx="3942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nline Resource 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3099A11-9159-6143-A4A7-13712BDC29D4}"/>
              </a:ext>
            </a:extLst>
          </p:cNvPr>
          <p:cNvSpPr txBox="1"/>
          <p:nvPr/>
        </p:nvSpPr>
        <p:spPr>
          <a:xfrm>
            <a:off x="9059473" y="2374761"/>
            <a:ext cx="238626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2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-MCT-3 Droplets 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86DE8183-10E4-0A4C-95F1-9AC41E0164A8}"/>
              </a:ext>
            </a:extLst>
          </p:cNvPr>
          <p:cNvCxnSpPr>
            <a:cxnSpLocks/>
          </p:cNvCxnSpPr>
          <p:nvPr/>
        </p:nvCxnSpPr>
        <p:spPr>
          <a:xfrm>
            <a:off x="9386889" y="2736331"/>
            <a:ext cx="1" cy="742819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03D2A89E-5158-3E4B-8E92-2320E0ACAEE0}"/>
              </a:ext>
            </a:extLst>
          </p:cNvPr>
          <p:cNvCxnSpPr>
            <a:cxnSpLocks/>
          </p:cNvCxnSpPr>
          <p:nvPr/>
        </p:nvCxnSpPr>
        <p:spPr>
          <a:xfrm flipH="1">
            <a:off x="8821009" y="2651760"/>
            <a:ext cx="403001" cy="84571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94B6E653-3756-784E-BDE4-368A66B134C4}"/>
              </a:ext>
            </a:extLst>
          </p:cNvPr>
          <p:cNvSpPr txBox="1"/>
          <p:nvPr/>
        </p:nvSpPr>
        <p:spPr>
          <a:xfrm>
            <a:off x="-283413" y="1064870"/>
            <a:ext cx="18450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83A6BFE-DD25-A841-BB18-269836DE56FE}"/>
              </a:ext>
            </a:extLst>
          </p:cNvPr>
          <p:cNvSpPr txBox="1"/>
          <p:nvPr/>
        </p:nvSpPr>
        <p:spPr>
          <a:xfrm>
            <a:off x="6823047" y="1001365"/>
            <a:ext cx="18450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219182859"/>
      </p:ext>
    </p:extLst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5254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18</Words>
  <Application>Microsoft Office PowerPoint</Application>
  <PresentationFormat>Widescreen</PresentationFormat>
  <Paragraphs>5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1_Office Theme</vt:lpstr>
      <vt:lpstr>Effects of GW on Chemical and Biological Balloon Surface Photo-MCT-3 Activation</vt:lpstr>
    </vt:vector>
  </TitlesOfParts>
  <Company>Monas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Dear</dc:creator>
  <cp:lastModifiedBy>Anthony Dear</cp:lastModifiedBy>
  <cp:revision>9</cp:revision>
  <dcterms:created xsi:type="dcterms:W3CDTF">2023-01-04T23:35:19Z</dcterms:created>
  <dcterms:modified xsi:type="dcterms:W3CDTF">2023-01-05T00:26:36Z</dcterms:modified>
</cp:coreProperties>
</file>